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23.wmf" ContentType="image/x-wmf"/>
  <Override PartName="/ppt/media/image22.wmf" ContentType="image/x-wmf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3.xml.rels" ContentType="application/vnd.openxmlformats-package.relationships+xml"/>
  <Override PartName="/ppt/slides/_rels/slide21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291BC-01E8-4EDE-AB16-AFA21A17A7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37196-E382-4F5C-B0EE-46D13FD12A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0AE34-8BD8-4168-8165-E0A53CC723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178514-1B33-4D82-91A1-8EE3485793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0E43D-C895-4036-A95C-AA0E8CA7EB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DDE1FB-4D7D-44B5-9448-1580BA79D4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C77DB-1A6E-4FAC-A80F-85A722487E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B5657-D647-4E45-834C-BB97970708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0CF4D-C200-4B19-B604-D8F60B0170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11F09-68F9-4BAF-9B08-2E50F5DD50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4D775-9584-4F48-BCED-6DD33A064C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BC3DD-69C3-49AE-A391-32DFDF58AC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830407-0955-4F1E-870E-47B2F9B6870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2.wmf"/><Relationship Id="rId4" Type="http://schemas.openxmlformats.org/officeDocument/2006/relationships/oleObject" Target="../embeddings/oleObject2.bin"/><Relationship Id="rId5" Type="http://schemas.openxmlformats.org/officeDocument/2006/relationships/image" Target="../media/image23.wmf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3"/>
          <p:cNvSpPr/>
          <p:nvPr/>
        </p:nvSpPr>
        <p:spPr>
          <a:xfrm>
            <a:off x="372960" y="1274760"/>
            <a:ext cx="8543880" cy="463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Hemoglobin level significantly impacts the tumour cell survival fraction in humans after internal radiotherapy: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application of a preclinical radiobiology model to clinical data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tephan Walrand, Renaud Lhommel, Pierre Goffette, Marc Van den Eynde, Stanislas Pauwels, François Jama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niques Universitaires Saint Luc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Université Catholique de Louvain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venue Hippocrate 10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200 Brussels, Belgiu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tephan.walrand@uclouvain.b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Rectangle 12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1" name="Groupe 10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182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3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84" name="Groupe 4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185" name="Rectangle 5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ZoneTexte 6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75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87" name="ZoneTexte 8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ZoneTexte 9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9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ZoneTexte 13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ZoneTexte 14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Rectangle 15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3" name="Groupe 13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194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195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6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97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198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9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78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200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02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ZoneTexte 16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ZoneTexte 17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Rectangle 12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06" name="Groupe 10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207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8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09" name="Groupe 4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210" name="Rectangle 5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ZoneTexte 6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80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12" name="ZoneTexte 8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ZoneTexte 9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4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ZoneTexte 13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ZoneTexte 14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Rectangle 15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8" name="Groupe 13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219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220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21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222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223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4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83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225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27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ZoneTexte 16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ZoneTexte 17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Rectangle 12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1" name="Groupe 10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232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33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34" name="Groupe 4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235" name="Rectangle 5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ZoneTexte 6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85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37" name="ZoneTexte 8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ZoneTexte 9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9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ZoneTexte 13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ZoneTexte 14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Rectangle 15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3" name="Groupe 13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244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245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6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247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248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9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87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250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52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ZoneTexte 16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ZoneTexte 17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Rectangle 11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56" name="Groupe 9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257" name="Graphique 1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8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59" name="Groupe 3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260" name="Rectangle 4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1" name="ZoneTexte 5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89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62" name="ZoneTexte 7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ZoneTexte 8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64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ZoneTexte 12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ZoneTexte 13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Rectangle 15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8" name="Groupe 13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269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270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71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272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273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4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90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275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77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ZoneTexte 16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ZoneTexte 17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Rectangle 12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81" name="Groupe 10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282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3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84" name="Groupe 4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285" name="Rectangle 5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6" name="ZoneTexte 6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91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87" name="ZoneTexte 8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ZoneTexte 9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89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ZoneTexte 13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ZoneTexte 14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Rectangle 15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93" name="Groupe 13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294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295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96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297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298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9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92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300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2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ZoneTexte 16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ZoneTexte 17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Rectangle 54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Groupe 44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44" name="Groupe 20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45" name="Graphique 6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ffffff"/>
                    </a:solidFill>
                    <a:latin typeface="Calibri"/>
                  </a:rPr>
                  <a:t>OER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47" name="Groupe 7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48" name="Rectangle 8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ZoneTexte 9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53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0" name="ZoneTexte 11"/>
              <p:cNvSpPr/>
              <p:nvPr/>
            </p:nvSpPr>
            <p:spPr>
              <a:xfrm>
                <a:off x="7233480" y="3305520"/>
                <a:ext cx="336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70c0"/>
                    </a:solidFill>
                    <a:latin typeface="Calibri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ZoneTexte 12"/>
              <p:cNvSpPr/>
              <p:nvPr/>
            </p:nvSpPr>
            <p:spPr>
              <a:xfrm>
                <a:off x="5776200" y="4674240"/>
                <a:ext cx="336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b0f0"/>
                    </a:solidFill>
                    <a:latin typeface="Calibri"/>
                  </a:rPr>
                  <a:t>1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ZoneTexte 13"/>
              <p:cNvSpPr/>
              <p:nvPr/>
            </p:nvSpPr>
            <p:spPr>
              <a:xfrm>
                <a:off x="4779720" y="4397760"/>
                <a:ext cx="336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b050"/>
                    </a:solidFill>
                    <a:latin typeface="Calibri"/>
                  </a:rPr>
                  <a:t>13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ZoneTexte 14"/>
              <p:cNvSpPr/>
              <p:nvPr/>
            </p:nvSpPr>
            <p:spPr>
              <a:xfrm>
                <a:off x="3080520" y="2962440"/>
                <a:ext cx="336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92d050"/>
                    </a:solidFill>
                    <a:latin typeface="Calibri"/>
                  </a:rPr>
                  <a:t>13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ZoneTexte 10"/>
              <p:cNvSpPr/>
              <p:nvPr/>
            </p:nvSpPr>
            <p:spPr>
              <a:xfrm>
                <a:off x="5230440" y="4507200"/>
                <a:ext cx="45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ffc000"/>
                    </a:solidFill>
                    <a:latin typeface="Calibri"/>
                  </a:rPr>
                  <a:t>13.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ZoneTexte 15"/>
              <p:cNvSpPr/>
              <p:nvPr/>
            </p:nvSpPr>
            <p:spPr>
              <a:xfrm>
                <a:off x="5753160" y="5199120"/>
                <a:ext cx="45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ff7c80"/>
                    </a:solidFill>
                    <a:latin typeface="Calibri"/>
                  </a:rPr>
                  <a:t>13.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ZoneTexte 16"/>
              <p:cNvSpPr/>
              <p:nvPr/>
            </p:nvSpPr>
            <p:spPr>
              <a:xfrm>
                <a:off x="5959080" y="5490360"/>
                <a:ext cx="45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ff6600"/>
                    </a:solidFill>
                    <a:latin typeface="Calibri"/>
                  </a:rPr>
                  <a:t>14.3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ZoneTexte 17"/>
              <p:cNvSpPr/>
              <p:nvPr/>
            </p:nvSpPr>
            <p:spPr>
              <a:xfrm>
                <a:off x="4879080" y="4892760"/>
                <a:ext cx="45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ff0000"/>
                    </a:solidFill>
                    <a:latin typeface="Calibri"/>
                  </a:rPr>
                  <a:t>14.8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8" name="ZoneTexte 46"/>
            <p:cNvSpPr/>
            <p:nvPr/>
          </p:nvSpPr>
          <p:spPr>
            <a:xfrm>
              <a:off x="4176360" y="2408040"/>
              <a:ext cx="9748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HEF x D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ZoneTexte 47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ZoneTexte 48"/>
            <p:cNvSpPr/>
            <p:nvPr/>
          </p:nvSpPr>
          <p:spPr>
            <a:xfrm>
              <a:off x="7482240" y="3285720"/>
              <a:ext cx="38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70c0"/>
                  </a:solidFill>
                  <a:latin typeface="Calibri"/>
                </a:rPr>
                <a:t>H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ZoneTexte 49"/>
            <p:cNvSpPr/>
            <p:nvPr/>
          </p:nvSpPr>
          <p:spPr>
            <a:xfrm>
              <a:off x="4465080" y="5024880"/>
              <a:ext cx="38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ff0000"/>
                  </a:solidFill>
                  <a:latin typeface="Calibri"/>
                </a:rPr>
                <a:t>H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ZoneTexte 5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3" name="ZoneTexte 41"/>
          <p:cNvSpPr/>
          <p:nvPr/>
        </p:nvSpPr>
        <p:spPr>
          <a:xfrm>
            <a:off x="1458000" y="711360"/>
            <a:ext cx="195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Hb Enhancement Facto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ZoneTexte 55"/>
          <p:cNvSpPr/>
          <p:nvPr/>
        </p:nvSpPr>
        <p:spPr>
          <a:xfrm>
            <a:off x="1468800" y="1092240"/>
            <a:ext cx="1678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HEF = 1 + k (Hb – 1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6" name="Groupe 60"/>
          <p:cNvGrpSpPr/>
          <p:nvPr/>
        </p:nvGrpSpPr>
        <p:grpSpPr>
          <a:xfrm>
            <a:off x="5886360" y="317520"/>
            <a:ext cx="1935360" cy="1234800"/>
            <a:chOff x="5886360" y="317520"/>
            <a:chExt cx="1935360" cy="1234800"/>
          </a:xfrm>
        </p:grpSpPr>
        <p:grpSp>
          <p:nvGrpSpPr>
            <p:cNvPr id="67" name="Groupe 51"/>
            <p:cNvGrpSpPr/>
            <p:nvPr/>
          </p:nvGrpSpPr>
          <p:grpSpPr>
            <a:xfrm>
              <a:off x="5886360" y="317520"/>
              <a:ext cx="1935360" cy="1006200"/>
              <a:chOff x="5886360" y="317520"/>
              <a:chExt cx="1935360" cy="1006200"/>
            </a:xfrm>
          </p:grpSpPr>
          <p:grpSp>
            <p:nvGrpSpPr>
              <p:cNvPr id="68" name="Groupe 43"/>
              <p:cNvGrpSpPr/>
              <p:nvPr/>
            </p:nvGrpSpPr>
            <p:grpSpPr>
              <a:xfrm>
                <a:off x="6219000" y="317520"/>
                <a:ext cx="1602720" cy="1006200"/>
                <a:chOff x="6219000" y="317520"/>
                <a:chExt cx="1602720" cy="1006200"/>
              </a:xfrm>
            </p:grpSpPr>
            <p:grpSp>
              <p:nvGrpSpPr>
                <p:cNvPr id="69" name="Groupe 31"/>
                <p:cNvGrpSpPr/>
                <p:nvPr/>
              </p:nvGrpSpPr>
              <p:grpSpPr>
                <a:xfrm>
                  <a:off x="6689520" y="353880"/>
                  <a:ext cx="1132200" cy="729720"/>
                  <a:chOff x="6689520" y="353880"/>
                  <a:chExt cx="1132200" cy="729720"/>
                </a:xfrm>
              </p:grpSpPr>
              <p:sp>
                <p:nvSpPr>
                  <p:cNvPr id="70" name="Connecteur droit 32"/>
                  <p:cNvSpPr/>
                  <p:nvPr/>
                </p:nvSpPr>
                <p:spPr>
                  <a:xfrm flipH="1">
                    <a:off x="6689520" y="353880"/>
                    <a:ext cx="1440" cy="7297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" name="Connecteur droit 33"/>
                  <p:cNvSpPr/>
                  <p:nvPr/>
                </p:nvSpPr>
                <p:spPr>
                  <a:xfrm>
                    <a:off x="6689520" y="1082160"/>
                    <a:ext cx="113220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72" name="Connecteur droit 34"/>
                <p:cNvSpPr/>
                <p:nvPr/>
              </p:nvSpPr>
              <p:spPr>
                <a:xfrm flipV="1">
                  <a:off x="6689520" y="426960"/>
                  <a:ext cx="1095480" cy="437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" name="ZoneTexte 35"/>
                <p:cNvSpPr/>
                <p:nvPr/>
              </p:nvSpPr>
              <p:spPr>
                <a:xfrm>
                  <a:off x="6219000" y="317520"/>
                  <a:ext cx="421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Calibri"/>
                    </a:rPr>
                    <a:t>HEF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" name="ZoneTexte 36"/>
                <p:cNvSpPr/>
                <p:nvPr/>
              </p:nvSpPr>
              <p:spPr>
                <a:xfrm>
                  <a:off x="7095600" y="1047240"/>
                  <a:ext cx="358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Calibri"/>
                    </a:rPr>
                    <a:t>Hb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" name="ZoneTexte 37"/>
                <p:cNvSpPr/>
                <p:nvPr/>
              </p:nvSpPr>
              <p:spPr>
                <a:xfrm>
                  <a:off x="6492960" y="545760"/>
                  <a:ext cx="258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Calibri"/>
                    </a:rPr>
                    <a:t>1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cxnSp>
            <p:nvCxnSpPr>
              <p:cNvPr id="76" name="Connecteur droit avec flèche 45"/>
              <p:cNvCxnSpPr/>
              <p:nvPr/>
            </p:nvCxnSpPr>
            <p:spPr>
              <a:xfrm>
                <a:off x="5886360" y="800280"/>
                <a:ext cx="328320" cy="2160"/>
              </a:xfrm>
              <a:prstGeom prst="straightConnector1">
                <a:avLst/>
              </a:prstGeom>
              <a:ln w="2232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sp>
          <p:nvSpPr>
            <p:cNvPr id="77" name="ZoneTexte 57"/>
            <p:cNvSpPr/>
            <p:nvPr/>
          </p:nvSpPr>
          <p:spPr>
            <a:xfrm>
              <a:off x="7081200" y="1245240"/>
              <a:ext cx="44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400" spc="-1" strike="noStrike">
                  <a:solidFill>
                    <a:srgbClr val="000000"/>
                  </a:solidFill>
                  <a:latin typeface="Calibri"/>
                </a:rPr>
                <a:t>k&gt;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8" name="Groupe 63"/>
          <p:cNvGrpSpPr/>
          <p:nvPr/>
        </p:nvGrpSpPr>
        <p:grpSpPr>
          <a:xfrm>
            <a:off x="2387520" y="317520"/>
            <a:ext cx="3206880" cy="4247280"/>
            <a:chOff x="2387520" y="317520"/>
            <a:chExt cx="3206880" cy="4247280"/>
          </a:xfrm>
        </p:grpSpPr>
        <p:grpSp>
          <p:nvGrpSpPr>
            <p:cNvPr id="79" name="Groupe 59"/>
            <p:cNvGrpSpPr/>
            <p:nvPr/>
          </p:nvGrpSpPr>
          <p:grpSpPr>
            <a:xfrm>
              <a:off x="3991680" y="317520"/>
              <a:ext cx="1602720" cy="1235520"/>
              <a:chOff x="3991680" y="317520"/>
              <a:chExt cx="1602720" cy="1235520"/>
            </a:xfrm>
          </p:grpSpPr>
          <p:grpSp>
            <p:nvGrpSpPr>
              <p:cNvPr id="80" name="Groupe 42"/>
              <p:cNvGrpSpPr/>
              <p:nvPr/>
            </p:nvGrpSpPr>
            <p:grpSpPr>
              <a:xfrm>
                <a:off x="3991680" y="317520"/>
                <a:ext cx="1602720" cy="1006920"/>
                <a:chOff x="3991680" y="317520"/>
                <a:chExt cx="1602720" cy="1006920"/>
              </a:xfrm>
            </p:grpSpPr>
            <p:grpSp>
              <p:nvGrpSpPr>
                <p:cNvPr id="81" name="Groupe 25"/>
                <p:cNvGrpSpPr/>
                <p:nvPr/>
              </p:nvGrpSpPr>
              <p:grpSpPr>
                <a:xfrm>
                  <a:off x="4462200" y="353880"/>
                  <a:ext cx="1132200" cy="730440"/>
                  <a:chOff x="4462200" y="353880"/>
                  <a:chExt cx="1132200" cy="730440"/>
                </a:xfrm>
              </p:grpSpPr>
              <p:sp>
                <p:nvSpPr>
                  <p:cNvPr id="82" name="Connecteur droit 22"/>
                  <p:cNvSpPr/>
                  <p:nvPr/>
                </p:nvSpPr>
                <p:spPr>
                  <a:xfrm flipH="1">
                    <a:off x="4462200" y="353880"/>
                    <a:ext cx="1440" cy="730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" name="Connecteur droit 24"/>
                  <p:cNvSpPr/>
                  <p:nvPr/>
                </p:nvSpPr>
                <p:spPr>
                  <a:xfrm>
                    <a:off x="4462200" y="1082880"/>
                    <a:ext cx="113220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84" name="Connecteur droit 27"/>
                <p:cNvSpPr/>
                <p:nvPr/>
              </p:nvSpPr>
              <p:spPr>
                <a:xfrm>
                  <a:off x="4462920" y="682560"/>
                  <a:ext cx="109548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" name="ZoneTexte 28"/>
                <p:cNvSpPr/>
                <p:nvPr/>
              </p:nvSpPr>
              <p:spPr>
                <a:xfrm>
                  <a:off x="3991680" y="317520"/>
                  <a:ext cx="421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Calibri"/>
                    </a:rPr>
                    <a:t>HEF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" name="ZoneTexte 29"/>
                <p:cNvSpPr/>
                <p:nvPr/>
              </p:nvSpPr>
              <p:spPr>
                <a:xfrm>
                  <a:off x="4868280" y="1047960"/>
                  <a:ext cx="358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Calibri"/>
                    </a:rPr>
                    <a:t>Hb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" name="ZoneTexte 30"/>
                <p:cNvSpPr/>
                <p:nvPr/>
              </p:nvSpPr>
              <p:spPr>
                <a:xfrm>
                  <a:off x="4265640" y="546120"/>
                  <a:ext cx="258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Calibri"/>
                    </a:rPr>
                    <a:t>1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88" name="ZoneTexte 56"/>
              <p:cNvSpPr/>
              <p:nvPr/>
            </p:nvSpPr>
            <p:spPr>
              <a:xfrm>
                <a:off x="4818240" y="1245960"/>
                <a:ext cx="4442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400" spc="-1" strike="noStrike">
                    <a:solidFill>
                      <a:srgbClr val="000000"/>
                    </a:solidFill>
                    <a:latin typeface="Calibri"/>
                  </a:rPr>
                  <a:t>k=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9" name="ZoneTexte 58"/>
            <p:cNvSpPr/>
            <p:nvPr/>
          </p:nvSpPr>
          <p:spPr>
            <a:xfrm>
              <a:off x="2387520" y="4196520"/>
              <a:ext cx="968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Calibri"/>
                </a:rPr>
                <a:t>k  = 0.00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0" name="ZoneTexte 62"/>
          <p:cNvSpPr/>
          <p:nvPr/>
        </p:nvSpPr>
        <p:spPr>
          <a:xfrm>
            <a:off x="1659240" y="-76320"/>
            <a:ext cx="5825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Dose-effect relationship labeled with patient Hb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ZoneTexte 61"/>
          <p:cNvSpPr/>
          <p:nvPr/>
        </p:nvSpPr>
        <p:spPr>
          <a:xfrm>
            <a:off x="3156840" y="1639800"/>
            <a:ext cx="3729960" cy="703800"/>
          </a:xfrm>
          <a:prstGeom prst="rect">
            <a:avLst/>
          </a:prstGeom>
          <a:solidFill>
            <a:srgbClr val="ffc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let see in the following anim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what will happen if we increase k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63"/>
          <p:cNvSpPr/>
          <p:nvPr/>
        </p:nvSpPr>
        <p:spPr>
          <a:xfrm>
            <a:off x="3038400" y="1566720"/>
            <a:ext cx="4052880" cy="839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afterEffect" fill="hold" presetClass="entr" presetID="22" presetSubtype="8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left)" transition="in">
                                      <p:cBhvr additive="repl">
                                        <p:cTn id="7" dur="500"/>
                                        <p:tgtEl>
                                          <p:spTgt spid="6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nodeType="withEffect" fill="hold" presetClass="exit" presetID="2" presetSubtype="4">
                                  <p:stCondLst>
                                    <p:cond delay="1000"/>
                                  </p:stCondLst>
                                  <p:childTnLst>
                                    <p:anim calcmode="lin" valueType="num">
                                      <p:cBhvr additive="base">
                                        <p:cTn id="9" dur="500"/>
                                        <p:tgtEl>
                                          <p:spTgt spid="9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0" dur="500"/>
                                        <p:tgtEl>
                                          <p:spTgt spid="9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1+#ppt_h/2"/>
                                          </p:val>
                                        </p:tav>
                                      </p:tavLst>
                                    </p:anim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2500"/>
                            </p:stCondLst>
                            <p:childTnLst>
                              <p:par>
                                <p:cTn id="13" nodeType="afterEffect" fill="hold" presetClass="emph" presetID="9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2000"/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opacity</p:attrName>
                                        </p:attrNameLst>
                                      </p:cBhvr>
                                      <p:to>
                                        <p:strVal val="0.5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Rectangle 12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06" name="Groupe 10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307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08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09" name="Groupe 4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310" name="Rectangle 5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1" name="ZoneTexte 6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93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12" name="ZoneTexte 8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ZoneTexte 9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14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ZoneTexte 14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ZoneTexte 15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Rectangle 15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18" name="Groupe 14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319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320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21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322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323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4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93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325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27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ZoneTexte 16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1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ZoneTexte 14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Rectangle 12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31" name="Groupe 10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332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3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34" name="Groupe 4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335" name="Rectangle 5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6" name="ZoneTexte 6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93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37" name="ZoneTexte 8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ZoneTexte 9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39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ZoneTexte 14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2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ZoneTexte 13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Rectangle 19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43" name="Groupe 13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344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345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46" name="Rectangle 3"/>
              <p:cNvSpPr/>
              <p:nvPr/>
            </p:nvSpPr>
            <p:spPr>
              <a:xfrm>
                <a:off x="2131560" y="489276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7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348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349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0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93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351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53" name="Groupe 17"/>
          <p:cNvGrpSpPr/>
          <p:nvPr/>
        </p:nvGrpSpPr>
        <p:grpSpPr>
          <a:xfrm>
            <a:off x="5641920" y="101520"/>
            <a:ext cx="2033640" cy="1392480"/>
            <a:chOff x="5641920" y="101520"/>
            <a:chExt cx="2033640" cy="1392480"/>
          </a:xfrm>
        </p:grpSpPr>
        <p:graphicFrame>
          <p:nvGraphicFramePr>
            <p:cNvPr id="354" name="Object 2"/>
            <p:cNvGraphicFramePr/>
            <p:nvPr/>
          </p:nvGraphicFramePr>
          <p:xfrm>
            <a:off x="5641920" y="101520"/>
            <a:ext cx="2033640" cy="139248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355" name="Object 2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5641920" y="101520"/>
                      <a:ext cx="2033640" cy="1392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56" name="Rectangle 16"/>
            <p:cNvSpPr/>
            <p:nvPr/>
          </p:nvSpPr>
          <p:spPr>
            <a:xfrm>
              <a:off x="7320600" y="199080"/>
              <a:ext cx="115200" cy="964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57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ZoneTexte 20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2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ZoneTexte 23"/>
          <p:cNvSpPr/>
          <p:nvPr/>
        </p:nvSpPr>
        <p:spPr>
          <a:xfrm>
            <a:off x="2376720" y="4556160"/>
            <a:ext cx="130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1" lang="en-GB" sz="18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 optimu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60" name="Groupe 26"/>
          <p:cNvGrpSpPr/>
          <p:nvPr/>
        </p:nvGrpSpPr>
        <p:grpSpPr>
          <a:xfrm>
            <a:off x="2943360" y="93600"/>
            <a:ext cx="4732200" cy="1392480"/>
            <a:chOff x="2943360" y="93600"/>
            <a:chExt cx="4732200" cy="1392480"/>
          </a:xfrm>
        </p:grpSpPr>
        <p:grpSp>
          <p:nvGrpSpPr>
            <p:cNvPr id="361" name="Groupe 15"/>
            <p:cNvGrpSpPr/>
            <p:nvPr/>
          </p:nvGrpSpPr>
          <p:grpSpPr>
            <a:xfrm>
              <a:off x="5641560" y="93600"/>
              <a:ext cx="2034000" cy="1392480"/>
              <a:chOff x="5641560" y="93600"/>
              <a:chExt cx="2034000" cy="1392480"/>
            </a:xfrm>
          </p:grpSpPr>
          <p:graphicFrame>
            <p:nvGraphicFramePr>
              <p:cNvPr id="362" name="Object 3"/>
              <p:cNvGraphicFramePr/>
              <p:nvPr/>
            </p:nvGraphicFramePr>
            <p:xfrm>
              <a:off x="5641560" y="93600"/>
              <a:ext cx="2034000" cy="1392480"/>
            </p:xfrm>
            <a:graphic>
              <a:graphicData uri="http://schemas.openxmlformats.org/presentationml/2006/ole">
                <p:oleObj r:id="rId4" spid="">
                  <p:embed/>
                  <p:pic>
                    <p:nvPicPr>
                      <p:cNvPr id="363" name="Object 3" descr=""/>
                      <p:cNvPicPr/>
                      <p:nvPr/>
                    </p:nvPicPr>
                    <p:blipFill>
                      <a:blip r:embed="rId5"/>
                      <a:stretch/>
                    </p:blipFill>
                    <p:spPr>
                      <a:xfrm>
                        <a:off x="5641560" y="93600"/>
                        <a:ext cx="2034000" cy="1392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364" name="Rectangle 30"/>
              <p:cNvSpPr/>
              <p:nvPr/>
            </p:nvSpPr>
            <p:spPr>
              <a:xfrm>
                <a:off x="6152400" y="381600"/>
                <a:ext cx="64080" cy="8280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00" bIns="360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65" name="ZoneTexte 28"/>
            <p:cNvSpPr/>
            <p:nvPr/>
          </p:nvSpPr>
          <p:spPr>
            <a:xfrm>
              <a:off x="2943360" y="605160"/>
              <a:ext cx="2436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d60093"/>
                  </a:solidFill>
                  <a:latin typeface="Calibri"/>
                </a:rPr>
                <a:t>optimal HEF per patien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66" name="ZoneTexte 27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15" dur="indefinite" restart="never" nodeType="tmRoot">
          <p:childTnLst>
            <p:seq>
              <p:cTn id="16" dur="indefinite" nodeType="mainSeq"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" fill="hold">
                            <p:stCondLst>
                              <p:cond delay="1000"/>
                            </p:stCondLst>
                            <p:childTnLst>
                              <p:par>
                                <p:cTn id="22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Rectangle 14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Calibri"/>
              </a:rPr>
              <a:t>-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4" name="Groupe 12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95" name="Graphique 6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Rectangle 5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7" name="Groupe 7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98" name="Rectangle 8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ZoneTexte 9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53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00" name="ZoneTexte 10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ZoneTexte 11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2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ZoneTexte 15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ZoneTexte 16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Rectangle 14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6" name="Groupe 12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107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Rectangle 5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09" name="Groupe 6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110" name="Rectangle 7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ZoneTexte 8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56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2" name="ZoneTexte 10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ZoneTexte 11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4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ZoneTexte 15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ZoneTexte 16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Rectangle 13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8" name="Groupe 11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119" name="Groupe 7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120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21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122" name="Rectangle 3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" name="ZoneTexte 4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60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24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5" name="ZoneTexte 9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ZoneTexte 10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7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ZoneTexte 14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ZoneTexte 15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Rectangle 12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1" name="Groupe 10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132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34" name="Groupe 4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135" name="Rectangle 5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ZoneTexte 6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63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7" name="ZoneTexte 8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ZoneTexte 9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9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ZoneTexte 13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ZoneTexte 14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Rectangle 15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3" name="Groupe 13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144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145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6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47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148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9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66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150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2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ZoneTexte 16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ZoneTexte 17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Rectangle 12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6" name="Groupe 10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pic>
          <p:nvPicPr>
            <p:cNvPr id="157" name="Graphique 3" descr=""/>
            <p:cNvPicPr/>
            <p:nvPr/>
          </p:nvPicPr>
          <p:blipFill>
            <a:blip r:embed="rId1"/>
            <a:stretch/>
          </p:blipFill>
          <p:spPr>
            <a:xfrm>
              <a:off x="1123920" y="1440000"/>
              <a:ext cx="6896160" cy="479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8" name="Rectangle 2"/>
            <p:cNvSpPr/>
            <p:nvPr/>
          </p:nvSpPr>
          <p:spPr>
            <a:xfrm>
              <a:off x="2167920" y="1651320"/>
              <a:ext cx="5573160" cy="764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59" name="Groupe 4"/>
            <p:cNvGrpSpPr/>
            <p:nvPr/>
          </p:nvGrpSpPr>
          <p:grpSpPr>
            <a:xfrm>
              <a:off x="2131560" y="3836520"/>
              <a:ext cx="1930320" cy="2221200"/>
              <a:chOff x="2131560" y="3836520"/>
              <a:chExt cx="1930320" cy="2221200"/>
            </a:xfrm>
          </p:grpSpPr>
          <p:sp>
            <p:nvSpPr>
              <p:cNvPr id="160" name="Rectangle 5"/>
              <p:cNvSpPr/>
              <p:nvPr/>
            </p:nvSpPr>
            <p:spPr>
              <a:xfrm>
                <a:off x="2131560" y="4892400"/>
                <a:ext cx="1930320" cy="11653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ZoneTexte 6"/>
              <p:cNvSpPr/>
              <p:nvPr/>
            </p:nvSpPr>
            <p:spPr>
              <a:xfrm>
                <a:off x="2360880" y="3836520"/>
                <a:ext cx="1002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R</a:t>
                </a:r>
                <a:r>
                  <a:rPr b="1" lang="en-GB" sz="18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r>
                  <a:rPr b="1" lang="en-GB" sz="1800" spc="-1" strike="noStrike">
                    <a:solidFill>
                      <a:srgbClr val="000000"/>
                    </a:solidFill>
                    <a:latin typeface="Calibri"/>
                  </a:rPr>
                  <a:t> = 0.69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62" name="ZoneTexte 8"/>
            <p:cNvSpPr/>
            <p:nvPr/>
          </p:nvSpPr>
          <p:spPr>
            <a:xfrm rot="16200000">
              <a:off x="-138960" y="352764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ZoneTexte 9"/>
            <p:cNvSpPr/>
            <p:nvPr/>
          </p:nvSpPr>
          <p:spPr>
            <a:xfrm>
              <a:off x="5005080" y="239328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4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ZoneTexte 13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ZoneTexte 15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Rectangle 15"/>
          <p:cNvSpPr/>
          <p:nvPr/>
        </p:nvSpPr>
        <p:spPr>
          <a:xfrm>
            <a:off x="1139760" y="1530360"/>
            <a:ext cx="6937560" cy="4819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8" name="Groupe 13"/>
          <p:cNvGrpSpPr/>
          <p:nvPr/>
        </p:nvGrpSpPr>
        <p:grpSpPr>
          <a:xfrm>
            <a:off x="1123920" y="1440000"/>
            <a:ext cx="6896160" cy="4790880"/>
            <a:chOff x="1123920" y="1440000"/>
            <a:chExt cx="6896160" cy="4790880"/>
          </a:xfrm>
        </p:grpSpPr>
        <p:grpSp>
          <p:nvGrpSpPr>
            <p:cNvPr id="169" name="Groupe 9"/>
            <p:cNvGrpSpPr/>
            <p:nvPr/>
          </p:nvGrpSpPr>
          <p:grpSpPr>
            <a:xfrm>
              <a:off x="1123920" y="1440000"/>
              <a:ext cx="6896160" cy="4790880"/>
              <a:chOff x="1123920" y="1440000"/>
              <a:chExt cx="6896160" cy="4790880"/>
            </a:xfrm>
          </p:grpSpPr>
          <p:pic>
            <p:nvPicPr>
              <p:cNvPr id="170" name="Graphiqu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123920" y="1440000"/>
                <a:ext cx="6896160" cy="479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1" name="Rectangle 5"/>
              <p:cNvSpPr/>
              <p:nvPr/>
            </p:nvSpPr>
            <p:spPr>
              <a:xfrm>
                <a:off x="2167920" y="1651320"/>
                <a:ext cx="5573160" cy="764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72" name="Groupe 6"/>
              <p:cNvGrpSpPr/>
              <p:nvPr/>
            </p:nvGrpSpPr>
            <p:grpSpPr>
              <a:xfrm>
                <a:off x="2131560" y="3836520"/>
                <a:ext cx="1930320" cy="2221200"/>
                <a:chOff x="2131560" y="3836520"/>
                <a:chExt cx="1930320" cy="2221200"/>
              </a:xfrm>
            </p:grpSpPr>
            <p:sp>
              <p:nvSpPr>
                <p:cNvPr id="173" name="Rectangle 7"/>
                <p:cNvSpPr/>
                <p:nvPr/>
              </p:nvSpPr>
              <p:spPr>
                <a:xfrm>
                  <a:off x="2131560" y="4892400"/>
                  <a:ext cx="1930320" cy="1165320"/>
                </a:xfrm>
                <a:prstGeom prst="rect">
                  <a:avLst/>
                </a:prstGeom>
                <a:solidFill>
                  <a:srgbClr val="ffffff"/>
                </a:solidFill>
                <a:ln w="255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4" name="ZoneTexte 8"/>
                <p:cNvSpPr/>
                <p:nvPr/>
              </p:nvSpPr>
              <p:spPr>
                <a:xfrm>
                  <a:off x="2360880" y="3836520"/>
                  <a:ext cx="1002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R</a:t>
                  </a:r>
                  <a:r>
                    <a:rPr b="1" lang="en-GB" sz="1800" spc="-1" strike="noStrike" baseline="30000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r>
                    <a:rPr b="1" lang="en-GB" sz="1800" spc="-1" strike="noStrike">
                      <a:solidFill>
                        <a:srgbClr val="000000"/>
                      </a:solidFill>
                      <a:latin typeface="Calibri"/>
                    </a:rPr>
                    <a:t> = 0.72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175" name="ZoneTexte 11"/>
            <p:cNvSpPr/>
            <p:nvPr/>
          </p:nvSpPr>
          <p:spPr>
            <a:xfrm rot="16200000">
              <a:off x="-146880" y="3526200"/>
              <a:ext cx="3121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tumor cells survival fraction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ZoneTexte 12"/>
            <p:cNvSpPr/>
            <p:nvPr/>
          </p:nvSpPr>
          <p:spPr>
            <a:xfrm>
              <a:off x="5006880" y="2388600"/>
              <a:ext cx="621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2000" spc="-1" strike="noStrike">
                  <a:solidFill>
                    <a:srgbClr val="000000"/>
                  </a:solidFill>
                  <a:latin typeface="Calibri"/>
                </a:rPr>
                <a:t>(Gy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7" name="ZoneTexte 16"/>
          <p:cNvSpPr/>
          <p:nvPr/>
        </p:nvSpPr>
        <p:spPr>
          <a:xfrm>
            <a:off x="7826760" y="6564240"/>
            <a:ext cx="13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UCL Brusse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ZoneTexte 16"/>
          <p:cNvSpPr/>
          <p:nvPr/>
        </p:nvSpPr>
        <p:spPr>
          <a:xfrm>
            <a:off x="2387520" y="4195800"/>
            <a:ext cx="96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k  = 0.0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ZoneTexte 17"/>
          <p:cNvSpPr/>
          <p:nvPr/>
        </p:nvSpPr>
        <p:spPr>
          <a:xfrm>
            <a:off x="4176720" y="2408400"/>
            <a:ext cx="974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</a:rPr>
              <a:t>HEF x 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28T07:02:16Z</dcterms:created>
  <dc:creator> </dc:creator>
  <dc:description/>
  <dc:language>en-US</dc:language>
  <cp:lastModifiedBy> </cp:lastModifiedBy>
  <dcterms:modified xsi:type="dcterms:W3CDTF">2012-03-19T08:10:20Z</dcterms:modified>
  <cp:revision>10</cp:revision>
  <dc:subject/>
  <dc:title>Diapositive 1</dc:title>
</cp:coreProperties>
</file>